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jgatesou\Documents\Nouveaux%20travaux\ARRAINA\Bar\Manipe%202014\FROGS-Blast%20selection\Abundance%20%25%20phylogen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aphe!$B$1</c:f>
              <c:strCache>
                <c:ptCount val="1"/>
                <c:pt idx="0">
                  <c:v>LH-LH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Graphe!$B$11:$B$17</c:f>
                <c:numCache>
                  <c:formatCode>General</c:formatCode>
                  <c:ptCount val="7"/>
                  <c:pt idx="0">
                    <c:v>5.2005476267113178</c:v>
                  </c:pt>
                  <c:pt idx="1">
                    <c:v>4.7157868519803783</c:v>
                  </c:pt>
                  <c:pt idx="2">
                    <c:v>0.3470673659728955</c:v>
                  </c:pt>
                  <c:pt idx="3">
                    <c:v>1.2523970017231632</c:v>
                  </c:pt>
                  <c:pt idx="4">
                    <c:v>0.84574377175555382</c:v>
                  </c:pt>
                  <c:pt idx="5">
                    <c:v>0.42923275119516241</c:v>
                  </c:pt>
                  <c:pt idx="6">
                    <c:v>0.241992639315049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Graphe!$A$2:$A$8</c:f>
              <c:strCache>
                <c:ptCount val="7"/>
                <c:pt idx="0">
                  <c:v>Alphaproteobacteria</c:v>
                </c:pt>
                <c:pt idx="1">
                  <c:v>Gammaproteobacteria</c:v>
                </c:pt>
                <c:pt idx="2">
                  <c:v>Other Proteobacteria</c:v>
                </c:pt>
                <c:pt idx="3">
                  <c:v>Bacteroidetes</c:v>
                </c:pt>
                <c:pt idx="4">
                  <c:v>Actinobacteria</c:v>
                </c:pt>
                <c:pt idx="5">
                  <c:v>Firmicutes</c:v>
                </c:pt>
                <c:pt idx="6">
                  <c:v>Other Bacteria</c:v>
                </c:pt>
              </c:strCache>
            </c:strRef>
          </c:cat>
          <c:val>
            <c:numRef>
              <c:f>Graphe!$B$2:$B$8</c:f>
              <c:numCache>
                <c:formatCode>General</c:formatCode>
                <c:ptCount val="7"/>
                <c:pt idx="0">
                  <c:v>33.220674967243539</c:v>
                </c:pt>
                <c:pt idx="1">
                  <c:v>58.523185143865568</c:v>
                </c:pt>
                <c:pt idx="2">
                  <c:v>1.7325454781223113</c:v>
                </c:pt>
                <c:pt idx="3">
                  <c:v>3.7365572113763732</c:v>
                </c:pt>
                <c:pt idx="4">
                  <c:v>1.7732167933509573</c:v>
                </c:pt>
                <c:pt idx="5">
                  <c:v>0.75237241256309961</c:v>
                </c:pt>
                <c:pt idx="6">
                  <c:v>0.25648021191425685</c:v>
                </c:pt>
              </c:numCache>
            </c:numRef>
          </c:val>
        </c:ser>
        <c:ser>
          <c:idx val="1"/>
          <c:order val="1"/>
          <c:tx>
            <c:strRef>
              <c:f>Graphe!$C$1</c:f>
              <c:strCache>
                <c:ptCount val="1"/>
                <c:pt idx="0">
                  <c:v>C-LH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Graphe!$C$11:$C$17</c:f>
                <c:numCache>
                  <c:formatCode>General</c:formatCode>
                  <c:ptCount val="7"/>
                  <c:pt idx="0">
                    <c:v>7.4289974294683017</c:v>
                  </c:pt>
                  <c:pt idx="1">
                    <c:v>7.9828602159821997</c:v>
                  </c:pt>
                  <c:pt idx="2">
                    <c:v>0.98875854969460564</c:v>
                  </c:pt>
                  <c:pt idx="3">
                    <c:v>1.4288729418270238</c:v>
                  </c:pt>
                  <c:pt idx="4">
                    <c:v>0.70932447359596795</c:v>
                  </c:pt>
                  <c:pt idx="5">
                    <c:v>0.21581692722130216</c:v>
                  </c:pt>
                  <c:pt idx="6">
                    <c:v>4.8313846748478112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Graphe!$A$2:$A$8</c:f>
              <c:strCache>
                <c:ptCount val="7"/>
                <c:pt idx="0">
                  <c:v>Alphaproteobacteria</c:v>
                </c:pt>
                <c:pt idx="1">
                  <c:v>Gammaproteobacteria</c:v>
                </c:pt>
                <c:pt idx="2">
                  <c:v>Other Proteobacteria</c:v>
                </c:pt>
                <c:pt idx="3">
                  <c:v>Bacteroidetes</c:v>
                </c:pt>
                <c:pt idx="4">
                  <c:v>Actinobacteria</c:v>
                </c:pt>
                <c:pt idx="5">
                  <c:v>Firmicutes</c:v>
                </c:pt>
                <c:pt idx="6">
                  <c:v>Other Bacteria</c:v>
                </c:pt>
              </c:strCache>
            </c:strRef>
          </c:cat>
          <c:val>
            <c:numRef>
              <c:f>Graphe!$C$2:$C$8</c:f>
              <c:numCache>
                <c:formatCode>General</c:formatCode>
                <c:ptCount val="7"/>
                <c:pt idx="0">
                  <c:v>44.565922285422481</c:v>
                </c:pt>
                <c:pt idx="1">
                  <c:v>47.829928608443225</c:v>
                </c:pt>
                <c:pt idx="2">
                  <c:v>2.2966371205692586</c:v>
                </c:pt>
                <c:pt idx="3">
                  <c:v>3.2752535176211217</c:v>
                </c:pt>
                <c:pt idx="4">
                  <c:v>1.1772613497208668</c:v>
                </c:pt>
                <c:pt idx="5">
                  <c:v>0.8532652103459698</c:v>
                </c:pt>
                <c:pt idx="6">
                  <c:v>4.8313846748478117E-4</c:v>
                </c:pt>
              </c:numCache>
            </c:numRef>
          </c:val>
        </c:ser>
        <c:ser>
          <c:idx val="2"/>
          <c:order val="2"/>
          <c:tx>
            <c:strRef>
              <c:f>Graphe!$D$1</c:f>
              <c:strCache>
                <c:ptCount val="1"/>
                <c:pt idx="0">
                  <c:v>C-T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Graphe!$D$11:$D$17</c:f>
                <c:numCache>
                  <c:formatCode>General</c:formatCode>
                  <c:ptCount val="7"/>
                  <c:pt idx="0">
                    <c:v>6.0896841378194662</c:v>
                  </c:pt>
                  <c:pt idx="1">
                    <c:v>4.7287565990172347</c:v>
                  </c:pt>
                  <c:pt idx="2">
                    <c:v>1.3249137670147784</c:v>
                  </c:pt>
                  <c:pt idx="3">
                    <c:v>1.639486052565557</c:v>
                  </c:pt>
                  <c:pt idx="4">
                    <c:v>0.78582299092371932</c:v>
                  </c:pt>
                  <c:pt idx="5">
                    <c:v>1.330753122424855</c:v>
                  </c:pt>
                  <c:pt idx="6">
                    <c:v>5.97387774820713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Graphe!$A$2:$A$8</c:f>
              <c:strCache>
                <c:ptCount val="7"/>
                <c:pt idx="0">
                  <c:v>Alphaproteobacteria</c:v>
                </c:pt>
                <c:pt idx="1">
                  <c:v>Gammaproteobacteria</c:v>
                </c:pt>
                <c:pt idx="2">
                  <c:v>Other Proteobacteria</c:v>
                </c:pt>
                <c:pt idx="3">
                  <c:v>Bacteroidetes</c:v>
                </c:pt>
                <c:pt idx="4">
                  <c:v>Actinobacteria</c:v>
                </c:pt>
                <c:pt idx="5">
                  <c:v>Firmicutes</c:v>
                </c:pt>
                <c:pt idx="6">
                  <c:v>Other Bacteria</c:v>
                </c:pt>
              </c:strCache>
            </c:strRef>
          </c:cat>
          <c:val>
            <c:numRef>
              <c:f>Graphe!$D$2:$D$8</c:f>
              <c:numCache>
                <c:formatCode>General</c:formatCode>
                <c:ptCount val="7"/>
                <c:pt idx="0">
                  <c:v>23.856817350161535</c:v>
                </c:pt>
                <c:pt idx="1">
                  <c:v>64.971167072728676</c:v>
                </c:pt>
                <c:pt idx="2">
                  <c:v>4.2989292038319649</c:v>
                </c:pt>
                <c:pt idx="3">
                  <c:v>1.903285748471933</c:v>
                </c:pt>
                <c:pt idx="4">
                  <c:v>2.8285384632672508</c:v>
                </c:pt>
                <c:pt idx="5">
                  <c:v>2.077065681011752</c:v>
                </c:pt>
                <c:pt idx="6">
                  <c:v>6.2092342826202643E-2</c:v>
                </c:pt>
              </c:numCache>
            </c:numRef>
          </c:val>
        </c:ser>
        <c:ser>
          <c:idx val="3"/>
          <c:order val="3"/>
          <c:tx>
            <c:strRef>
              <c:f>Graphe!$E$1</c:f>
              <c:strCache>
                <c:ptCount val="1"/>
                <c:pt idx="0">
                  <c:v>C-HG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Graphe!$E$11:$E$17</c:f>
                <c:numCache>
                  <c:formatCode>General</c:formatCode>
                  <c:ptCount val="7"/>
                  <c:pt idx="0">
                    <c:v>6.3436371098072684</c:v>
                  </c:pt>
                  <c:pt idx="1">
                    <c:v>6.2257829724645655</c:v>
                  </c:pt>
                  <c:pt idx="2">
                    <c:v>0.56134889983236347</c:v>
                  </c:pt>
                  <c:pt idx="3">
                    <c:v>0.56205277830912848</c:v>
                  </c:pt>
                  <c:pt idx="4">
                    <c:v>8.9844972230014086E-2</c:v>
                  </c:pt>
                  <c:pt idx="5">
                    <c:v>0.87598216101978177</c:v>
                  </c:pt>
                  <c:pt idx="6">
                    <c:v>0.168041283319333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Graphe!$A$2:$A$8</c:f>
              <c:strCache>
                <c:ptCount val="7"/>
                <c:pt idx="0">
                  <c:v>Alphaproteobacteria</c:v>
                </c:pt>
                <c:pt idx="1">
                  <c:v>Gammaproteobacteria</c:v>
                </c:pt>
                <c:pt idx="2">
                  <c:v>Other Proteobacteria</c:v>
                </c:pt>
                <c:pt idx="3">
                  <c:v>Bacteroidetes</c:v>
                </c:pt>
                <c:pt idx="4">
                  <c:v>Actinobacteria</c:v>
                </c:pt>
                <c:pt idx="5">
                  <c:v>Firmicutes</c:v>
                </c:pt>
                <c:pt idx="6">
                  <c:v>Other Bacteria</c:v>
                </c:pt>
              </c:strCache>
            </c:strRef>
          </c:cat>
          <c:val>
            <c:numRef>
              <c:f>Graphe!$E$2:$E$8</c:f>
              <c:numCache>
                <c:formatCode>General</c:formatCode>
                <c:ptCount val="7"/>
                <c:pt idx="0">
                  <c:v>41.509416611752698</c:v>
                </c:pt>
                <c:pt idx="1">
                  <c:v>54.232114357968669</c:v>
                </c:pt>
                <c:pt idx="2">
                  <c:v>1.4682789538316237</c:v>
                </c:pt>
                <c:pt idx="3">
                  <c:v>1.1307734600790877</c:v>
                </c:pt>
                <c:pt idx="4">
                  <c:v>0.11046768595316872</c:v>
                </c:pt>
                <c:pt idx="5">
                  <c:v>1.3355954935919689</c:v>
                </c:pt>
                <c:pt idx="6">
                  <c:v>0.20991605882347769</c:v>
                </c:pt>
              </c:numCache>
            </c:numRef>
          </c:val>
        </c:ser>
        <c:ser>
          <c:idx val="4"/>
          <c:order val="4"/>
          <c:tx>
            <c:strRef>
              <c:f>Graphe!$F$1</c:f>
              <c:strCache>
                <c:ptCount val="1"/>
                <c:pt idx="0">
                  <c:v>HG-HG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Graphe!$F$11:$F$17</c:f>
                <c:numCache>
                  <c:formatCode>General</c:formatCode>
                  <c:ptCount val="7"/>
                  <c:pt idx="0">
                    <c:v>5.6962347386809524</c:v>
                  </c:pt>
                  <c:pt idx="1">
                    <c:v>5.6967885522147874</c:v>
                  </c:pt>
                  <c:pt idx="2">
                    <c:v>0.82936895842064318</c:v>
                  </c:pt>
                  <c:pt idx="3">
                    <c:v>1.0193593811446797</c:v>
                  </c:pt>
                  <c:pt idx="4">
                    <c:v>0.4663558914486251</c:v>
                  </c:pt>
                  <c:pt idx="5">
                    <c:v>0.43666101112470301</c:v>
                  </c:pt>
                  <c:pt idx="6">
                    <c:v>0.376830234467602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Graphe!$A$2:$A$8</c:f>
              <c:strCache>
                <c:ptCount val="7"/>
                <c:pt idx="0">
                  <c:v>Alphaproteobacteria</c:v>
                </c:pt>
                <c:pt idx="1">
                  <c:v>Gammaproteobacteria</c:v>
                </c:pt>
                <c:pt idx="2">
                  <c:v>Other Proteobacteria</c:v>
                </c:pt>
                <c:pt idx="3">
                  <c:v>Bacteroidetes</c:v>
                </c:pt>
                <c:pt idx="4">
                  <c:v>Actinobacteria</c:v>
                </c:pt>
                <c:pt idx="5">
                  <c:v>Firmicutes</c:v>
                </c:pt>
                <c:pt idx="6">
                  <c:v>Other Bacteria</c:v>
                </c:pt>
              </c:strCache>
            </c:strRef>
          </c:cat>
          <c:val>
            <c:numRef>
              <c:f>Graphe!$F$2:$F$8</c:f>
              <c:numCache>
                <c:formatCode>General</c:formatCode>
                <c:ptCount val="7"/>
                <c:pt idx="0">
                  <c:v>38.162009269275899</c:v>
                </c:pt>
                <c:pt idx="1">
                  <c:v>55.882026734340464</c:v>
                </c:pt>
                <c:pt idx="2">
                  <c:v>2.5775838641683246</c:v>
                </c:pt>
                <c:pt idx="3">
                  <c:v>1.6325067169856016</c:v>
                </c:pt>
                <c:pt idx="4">
                  <c:v>0.8234782449714686</c:v>
                </c:pt>
                <c:pt idx="5">
                  <c:v>0.46090132376096865</c:v>
                </c:pt>
                <c:pt idx="6">
                  <c:v>0.457096258597110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298560"/>
        <c:axId val="101300096"/>
      </c:barChart>
      <c:catAx>
        <c:axId val="101298560"/>
        <c:scaling>
          <c:orientation val="minMax"/>
        </c:scaling>
        <c:delete val="0"/>
        <c:axPos val="b"/>
        <c:majorTickMark val="out"/>
        <c:minorTickMark val="none"/>
        <c:tickLblPos val="nextTo"/>
        <c:crossAx val="101300096"/>
        <c:crosses val="autoZero"/>
        <c:auto val="1"/>
        <c:lblAlgn val="ctr"/>
        <c:lblOffset val="100"/>
        <c:noMultiLvlLbl val="0"/>
      </c:catAx>
      <c:valAx>
        <c:axId val="101300096"/>
        <c:scaling>
          <c:orientation val="minMax"/>
          <c:max val="7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101298560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4684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05181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378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7036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8496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0031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4717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854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871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8598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8589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A592CE-A99D-460B-892E-7EF3182EF530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0A9CE8-9744-4312-8522-802E66A4BE6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052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2973325"/>
              </p:ext>
            </p:extLst>
          </p:nvPr>
        </p:nvGraphicFramePr>
        <p:xfrm>
          <a:off x="75421" y="1052736"/>
          <a:ext cx="9058710" cy="54352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89756" y="764704"/>
            <a:ext cx="3057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smtClean="0"/>
              <a:t>%</a:t>
            </a:r>
            <a:endParaRPr lang="en-GB" sz="1200" dirty="0"/>
          </a:p>
        </p:txBody>
      </p:sp>
      <p:sp>
        <p:nvSpPr>
          <p:cNvPr id="6" name="ZoneTexte 5"/>
          <p:cNvSpPr txBox="1"/>
          <p:nvPr/>
        </p:nvSpPr>
        <p:spPr>
          <a:xfrm>
            <a:off x="251520" y="188640"/>
            <a:ext cx="865870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dditional file 3 – Histogram showing the overwhelming dominance of Alpha- and Gamma-</a:t>
            </a:r>
            <a:r>
              <a:rPr lang="en-US" sz="1400" dirty="0" err="1"/>
              <a:t>Proteobacteria</a:t>
            </a:r>
            <a:r>
              <a:rPr lang="en-US" sz="1400" dirty="0"/>
              <a:t> among the</a:t>
            </a:r>
          </a:p>
          <a:p>
            <a:r>
              <a:rPr lang="en-US" sz="1400" dirty="0"/>
              <a:t>OTUs detected in every experimental group (% of mean relative abundance per individual).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9636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30</Words>
  <Application>Microsoft Office PowerPoint</Application>
  <PresentationFormat>Affichage à l'écra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el GATESOUPE, Inra Brest PDG-RBE-PFOM-ARN, 02</dc:creator>
  <cp:lastModifiedBy>Joel GATESOUPE</cp:lastModifiedBy>
  <cp:revision>7</cp:revision>
  <dcterms:created xsi:type="dcterms:W3CDTF">2015-08-21T08:16:49Z</dcterms:created>
  <dcterms:modified xsi:type="dcterms:W3CDTF">2016-10-28T13:44:05Z</dcterms:modified>
</cp:coreProperties>
</file>